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  <p:sldId id="259" r:id="rId4"/>
    <p:sldId id="260" r:id="rId5"/>
    <p:sldId id="304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5814"/>
  </p:normalViewPr>
  <p:slideViewPr>
    <p:cSldViewPr snapToGrid="0" snapToObjects="1">
      <p:cViewPr varScale="1">
        <p:scale>
          <a:sx n="112" d="100"/>
          <a:sy n="112" d="100"/>
        </p:scale>
        <p:origin x="57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0BDB72-FBFD-D342-857D-EDA137252E6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0D565AA-8450-C84B-B17A-C83823C3425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9D0D10-692D-C246-9E22-8866FDB949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D4475F-AD3E-574C-9778-536BD67C79DD}" type="datetimeFigureOut">
              <a:rPr lang="en-US" smtClean="0"/>
              <a:t>2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7BE35D-6051-424C-8312-1F74EE4849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F1ECAA-B378-794A-BADA-797C5C87AF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FEDD4-2A6F-5547-9421-76D7D13771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66367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F290F1-32D9-0A43-B68C-D47D1F63DF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A0E00E6-DD93-0D40-AFB1-971FD54250A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0DE02C-FB12-B44E-B895-F8DD82FBC8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D4475F-AD3E-574C-9778-536BD67C79DD}" type="datetimeFigureOut">
              <a:rPr lang="en-US" smtClean="0"/>
              <a:t>2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A193E0-9CCA-5A4F-87DE-FEDA594463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6F6C21-FFE0-644C-BA66-7690EFFFBC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FEDD4-2A6F-5547-9421-76D7D13771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60320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36DDB22-98DE-F14F-ABD5-3380F5E6790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D58F3E4-E10E-CE4D-AD34-73C642904B9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BEC0B8-114D-3142-AF40-EED37E2C08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D4475F-AD3E-574C-9778-536BD67C79DD}" type="datetimeFigureOut">
              <a:rPr lang="en-US" smtClean="0"/>
              <a:t>2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842DC9-81F7-FB4D-AAA8-DA34D3D8D5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1810BD-03F0-8546-88CF-F8F82B696E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FEDD4-2A6F-5547-9421-76D7D13771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09060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109909-781B-994D-84D0-7BD08E2880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A4099DC-61B1-8648-ACD9-49F5E1F8475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D8C539-3F82-7D41-98DB-57F98FC529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D4475F-AD3E-574C-9778-536BD67C79DD}" type="datetimeFigureOut">
              <a:rPr lang="en-US" smtClean="0"/>
              <a:t>2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D894F1-35F4-AE4E-AF1C-2EB3720EFF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6F32B7-B035-7B41-A7D5-58404AB39C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FEDD4-2A6F-5547-9421-76D7D13771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65346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E7E091-4E74-1640-926C-99126B036F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43AC4E0-B912-0C4B-8FE3-8016D5B487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83733D-C2AD-5D43-8214-9E8793452E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D4475F-AD3E-574C-9778-536BD67C79DD}" type="datetimeFigureOut">
              <a:rPr lang="en-US" smtClean="0"/>
              <a:t>2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F1E437-D560-B14E-BFC0-D79783DD00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E5DAD5-A36D-1547-9985-A7FEF0248E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FEDD4-2A6F-5547-9421-76D7D13771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0397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AB0BC9-4973-3B4A-B170-909C614938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5FF47EB-798B-724B-B8CB-CC9BB8999EC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FC9D946-DA55-2048-BDEE-CFF0FAC05B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2BBBB8E-00AB-1449-828B-392C190EEA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D4475F-AD3E-574C-9778-536BD67C79DD}" type="datetimeFigureOut">
              <a:rPr lang="en-US" smtClean="0"/>
              <a:t>2/26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BF7E76B-1C12-3E4A-B3BA-271E9434BE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A3599C7-6F2F-9F44-AEF2-3CF6854CB2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FEDD4-2A6F-5547-9421-76D7D13771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198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BFBE7D-F1F3-0140-94C8-8B25A63407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174D397-E52E-0745-B1E7-289EC5B16A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EDCC207-D831-BE49-B95D-6F7FF9784B3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83AAEA8-9691-AE4B-9D8C-784E9A67D5E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F0548BD-C1F7-164E-9332-E122D9407BD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EED8FD7-B48A-754F-BAC8-9A6F102021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D4475F-AD3E-574C-9778-536BD67C79DD}" type="datetimeFigureOut">
              <a:rPr lang="en-US" smtClean="0"/>
              <a:t>2/26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E8A3CB6-7DED-8A44-8FE8-60DE058B7A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042CBD4-C1CA-2148-BF1C-DA20F984C1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FEDD4-2A6F-5547-9421-76D7D13771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1124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E54A81-90E5-984E-89F9-55FA296295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0B78D01-00E6-774E-97D9-757A0A3D16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D4475F-AD3E-574C-9778-536BD67C79DD}" type="datetimeFigureOut">
              <a:rPr lang="en-US" smtClean="0"/>
              <a:t>2/26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8E8FD0D-5272-434F-8A26-858D5B6184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4AE8CF2-48C2-3544-B8D8-83E71A1082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FEDD4-2A6F-5547-9421-76D7D13771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86332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3A50C21-4213-CE40-AFCF-3A4B204877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D4475F-AD3E-574C-9778-536BD67C79DD}" type="datetimeFigureOut">
              <a:rPr lang="en-US" smtClean="0"/>
              <a:t>2/26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1C8B205-74CD-234B-B052-DC054D94C4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2224D10-0A53-634F-AB7A-E74CC1B66E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FEDD4-2A6F-5547-9421-76D7D13771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27830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F27B44-1ED4-D841-886D-CD01C6B5FA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3869632-E703-AE42-BB61-87EDA39FB82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D205DC5-E9BC-064B-8F8B-A62CE6A003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DCFAA43-277E-E44A-AE4B-A96A408601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D4475F-AD3E-574C-9778-536BD67C79DD}" type="datetimeFigureOut">
              <a:rPr lang="en-US" smtClean="0"/>
              <a:t>2/26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BF670DA-3480-F14B-8EF0-0ADF6DE723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C10F2C4-9EFE-C34C-AEF7-2D5E68122B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FEDD4-2A6F-5547-9421-76D7D13771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23191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28C7F4-47C1-234B-9C56-D04C45F517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1B909CD-A889-9246-AD72-321A256540A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179420E-E919-F74F-8E96-4B5D33C5DCE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1FFF2CF-5C3F-9B48-960E-3DD668CD0E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D4475F-AD3E-574C-9778-536BD67C79DD}" type="datetimeFigureOut">
              <a:rPr lang="en-US" smtClean="0"/>
              <a:t>2/26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A6A36EF-723A-0A4A-A47B-9647A7F02B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791D88C-8010-6347-AB51-F5296768DF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FEDD4-2A6F-5547-9421-76D7D13771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98455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79F50A9-BEAF-D048-B164-0B47B24E50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FFC48E3-7729-574C-AE2D-AC7EFE8ADE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FB05A3-2BF1-6C41-827F-09AEC364814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D4475F-AD3E-574C-9778-536BD67C79DD}" type="datetimeFigureOut">
              <a:rPr lang="en-US" smtClean="0"/>
              <a:t>2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3EF4E1-0AD9-D44C-B689-DED57348F56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31DBAA-BDFB-8545-8365-509DA3E8944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1FEDD4-2A6F-5547-9421-76D7D13771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21071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6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3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2235200"/>
            <a:ext cx="9144000" cy="2387600"/>
          </a:xfrm>
        </p:spPr>
        <p:txBody>
          <a:bodyPr>
            <a:normAutofit fontScale="90000"/>
          </a:bodyPr>
          <a:lstStyle/>
          <a:p>
            <a:r>
              <a:rPr lang="en-US" dirty="0"/>
              <a:t>Resuscitation Leadership Training  </a:t>
            </a:r>
            <a:br>
              <a:rPr lang="en-US" dirty="0"/>
            </a:br>
            <a:br>
              <a:rPr lang="en-US" dirty="0"/>
            </a:br>
            <a:r>
              <a:rPr lang="en-US" sz="4400" dirty="0"/>
              <a:t>Simulation Case: Wide Complex Tachycardia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5202238"/>
            <a:ext cx="9144000" cy="1655762"/>
          </a:xfrm>
        </p:spPr>
        <p:txBody>
          <a:bodyPr/>
          <a:lstStyle/>
          <a:p>
            <a:r>
              <a:rPr lang="en-US" dirty="0"/>
              <a:t>All Material Author Owned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664416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Initial EKG</a:t>
            </a:r>
          </a:p>
        </p:txBody>
      </p:sp>
      <p:pic>
        <p:nvPicPr>
          <p:cNvPr id="3" name="Picture 2" descr="Monomorphic-VT-3-LITFL.jpg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69641" y="1417637"/>
            <a:ext cx="8070581" cy="40400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6753633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XR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81391" y="1242227"/>
            <a:ext cx="5201382" cy="52013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1662763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POCUS </a:t>
            </a:r>
            <a:r>
              <a:rPr lang="en-US" dirty="0"/>
              <a:t>- Echo</a:t>
            </a:r>
          </a:p>
        </p:txBody>
      </p:sp>
      <p:pic>
        <p:nvPicPr>
          <p:cNvPr id="3" name="Normal EF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2811780" y="1413119"/>
            <a:ext cx="6773008" cy="50797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7335769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0119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Repeat EKG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/>
          <a:srcRect l="2363"/>
          <a:stretch/>
        </p:blipFill>
        <p:spPr>
          <a:xfrm>
            <a:off x="1823244" y="1766888"/>
            <a:ext cx="7935912" cy="381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838247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3</Words>
  <Application>Microsoft Macintosh PowerPoint</Application>
  <PresentationFormat>Widescreen</PresentationFormat>
  <Paragraphs>6</Paragraphs>
  <Slides>5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Resuscitation Leadership Training    Simulation Case: Wide Complex Tachycardia</vt:lpstr>
      <vt:lpstr>Initial EKG</vt:lpstr>
      <vt:lpstr>CXR</vt:lpstr>
      <vt:lpstr>POCUS - Echo</vt:lpstr>
      <vt:lpstr>Repeat EKG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esuscitation Leadership Training    Simulation Case: Wide Complex Tachycardia</dc:title>
  <dc:creator>Microsoft Office User</dc:creator>
  <cp:lastModifiedBy>Microsoft Office User</cp:lastModifiedBy>
  <cp:revision>3</cp:revision>
  <dcterms:created xsi:type="dcterms:W3CDTF">2022-02-26T18:26:06Z</dcterms:created>
  <dcterms:modified xsi:type="dcterms:W3CDTF">2022-02-26T19:13:46Z</dcterms:modified>
</cp:coreProperties>
</file>